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1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00" autoAdjust="0"/>
    <p:restoredTop sz="94643" autoAdjust="0"/>
  </p:normalViewPr>
  <p:slideViewPr>
    <p:cSldViewPr snapToGrid="0">
      <p:cViewPr varScale="1">
        <p:scale>
          <a:sx n="97" d="100"/>
          <a:sy n="97" d="100"/>
        </p:scale>
        <p:origin x="1458" y="84"/>
      </p:cViewPr>
      <p:guideLst>
        <p:guide orient="horz" pos="1865"/>
        <p:guide pos="31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smtClean="0"/>
            </a:lvl1pPr>
          </a:lstStyle>
          <a:p>
            <a:pPr>
              <a:defRPr/>
            </a:pPr>
            <a:fld id="{1C9D0A36-DE4C-4440-8F6C-AEF2CA54FF85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smtClean="0"/>
            </a:lvl1pPr>
          </a:lstStyle>
          <a:p>
            <a:pPr>
              <a:defRPr/>
            </a:pPr>
            <a:fld id="{A95C0E93-8D30-4A30-9328-4E0FB45E5BB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813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A5558D-8F49-48AC-9AD1-376CB1A7E39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B339-7594-4B22-A554-7B400AD98A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87302B-CA7A-4E6B-A47F-DC332C23FD1A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B45D9B-561E-4F88-9AB5-8E4B827DF6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E4499-94DD-4CAD-8E21-EA1AF54156B0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531EF-E7B4-422A-88BB-47B0975638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5F7945-BBD4-4978-87EC-C7D80B463AB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82FDBD-73E8-482B-8B0A-795AAB09BF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D2AAE2-0E64-4293-B29A-F50BD23856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6B7EBA-6E88-45F3-AFA7-7E4748CF9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A8DA1D-4DE8-42BC-BD9E-CD5459035D5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6093AD-FB35-44EB-A78B-A8D57029F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262641-2E0D-4F47-A695-B40F164E5298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1291B-6319-4CBE-8716-8CDE732F976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FDA3E8-4DC9-49DD-84E5-CA89B17ADDB1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8FBAA-AA12-4A4C-97FB-28969739D8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0EB80-9B42-4E8C-93AE-BFC21D3B5E8D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D0E515-5FC4-4574-A5BE-D608BFDDD9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0ED7-D082-44C4-A6ED-5DA8752B747B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DAFEFA-4281-4F12-A99A-44E264AE90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59D499-0483-4786-8C94-B4A7588B0873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57DE42-43C2-45E9-BD3A-849BD950B3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A6D2247-3288-4C0A-8C55-B2B65727C759}" type="datetimeFigureOut">
              <a:rPr lang="en-US"/>
              <a:pPr>
                <a:defRPr/>
              </a:pPr>
              <a:t>10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34A502B-99B5-4993-AC5A-918CFA4C90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5557447" y="3194386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KK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B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557447" y="252176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KKA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47375" y="4743158"/>
            <a:ext cx="811407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 Fig.  Western blot positive control for </a:t>
            </a:r>
            <a:r>
              <a:rPr lang="en-CA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KKA</a:t>
            </a:r>
            <a:r>
              <a:rPr lang="en-CA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B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THP-1 cells, differentiated to M1 with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rbolesters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100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A, 72 h), were polarized to M1 with LPS (500 ng/ml) 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hicle (PBS,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l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or 2 h, and analyzed by Western blot for the presence of phosphorylated IKKA/B and IKKA. Arrowhead indicates predicted migration position of IKKA/B (84 and 87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).  Approximately 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g of THP-1 were loaded per well.  HEK293T cells (30 µg, untreated) are included. 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8063" t="28653" r="48856" b="60708"/>
          <a:stretch/>
        </p:blipFill>
        <p:spPr>
          <a:xfrm>
            <a:off x="3354327" y="2365295"/>
            <a:ext cx="2244040" cy="752094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 rot="16200000">
            <a:off x="4238379" y="519222"/>
            <a:ext cx="143594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l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lang="en-CA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PS</a:t>
            </a:r>
          </a:p>
          <a:p>
            <a:endParaRPr lang="en-CA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293T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921656" y="1287685"/>
            <a:ext cx="8130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P-1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3750909" y="1637670"/>
            <a:ext cx="951725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385106" y="2307328"/>
            <a:ext cx="10502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  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385106" y="3065718"/>
            <a:ext cx="10502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  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t="17716" b="42720"/>
          <a:stretch/>
        </p:blipFill>
        <p:spPr>
          <a:xfrm>
            <a:off x="3338445" y="3132525"/>
            <a:ext cx="2275803" cy="6251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366" t="36785" r="25441" b="52377"/>
          <a:stretch/>
        </p:blipFill>
        <p:spPr>
          <a:xfrm>
            <a:off x="3329418" y="3765465"/>
            <a:ext cx="2256111" cy="5355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557447" y="393204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nceau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385106" y="3717353"/>
            <a:ext cx="10502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   </a:t>
            </a:r>
            <a:r>
              <a:rPr lang="en-CA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2741487" y="1425067"/>
            <a:ext cx="15632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marker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9981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31</TotalTime>
  <Words>118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OH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soubeyrand</dc:creator>
  <cp:lastModifiedBy>Sebastien Soubeyrand</cp:lastModifiedBy>
  <cp:revision>1210</cp:revision>
  <dcterms:created xsi:type="dcterms:W3CDTF">2017-11-23T16:07:42Z</dcterms:created>
  <dcterms:modified xsi:type="dcterms:W3CDTF">2019-10-09T12:49:21Z</dcterms:modified>
</cp:coreProperties>
</file>